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8" r:id="rId5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DA41953-3C86-4CEE-BD8B-CE18EC58BD8F}" v="1" dt="2023-08-30T13:37:05.07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1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oline Lilliecreutz" userId="S::carla25@ad.liu.se::373d378f-ca09-47b3-b1ed-ff78ca06275a" providerId="AD" clId="Web-{8DA41953-3C86-4CEE-BD8B-CE18EC58BD8F}"/>
    <pc:docChg chg="modSld">
      <pc:chgData name="Caroline Lilliecreutz" userId="S::carla25@ad.liu.se::373d378f-ca09-47b3-b1ed-ff78ca06275a" providerId="AD" clId="Web-{8DA41953-3C86-4CEE-BD8B-CE18EC58BD8F}" dt="2023-08-30T13:37:05.077" v="0" actId="20577"/>
      <pc:docMkLst>
        <pc:docMk/>
      </pc:docMkLst>
      <pc:sldChg chg="modSp">
        <pc:chgData name="Caroline Lilliecreutz" userId="S::carla25@ad.liu.se::373d378f-ca09-47b3-b1ed-ff78ca06275a" providerId="AD" clId="Web-{8DA41953-3C86-4CEE-BD8B-CE18EC58BD8F}" dt="2023-08-30T13:37:05.077" v="0" actId="20577"/>
        <pc:sldMkLst>
          <pc:docMk/>
          <pc:sldMk cId="2455701391" sldId="256"/>
        </pc:sldMkLst>
        <pc:spChg chg="mod">
          <ac:chgData name="Caroline Lilliecreutz" userId="S::carla25@ad.liu.se::373d378f-ca09-47b3-b1ed-ff78ca06275a" providerId="AD" clId="Web-{8DA41953-3C86-4CEE-BD8B-CE18EC58BD8F}" dt="2023-08-30T13:37:05.077" v="0" actId="20577"/>
          <ac:spMkLst>
            <pc:docMk/>
            <pc:sldMk cId="2455701391" sldId="256"/>
            <ac:spMk id="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om du vill redigera mall för underrubrikforma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68134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51679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56364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24217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83403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63725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97415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94626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27482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558281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59027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B9247E-4CC8-41E0-A173-C47A26BA3DDD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D9751-48A9-4C4E-A90B-AC40BD7B803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80603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z="18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800" b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a</a:t>
            </a:r>
            <a:r>
              <a:rPr lang="en-GB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Kaplan Meier survival analysis on </a:t>
            </a:r>
            <a:r>
              <a:rPr lang="en-GB" sz="180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ration of active </a:t>
            </a:r>
            <a:r>
              <a:rPr lang="en-GB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bour in women with </a:t>
            </a:r>
            <a:r>
              <a:rPr lang="en-GB" sz="18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gestational</a:t>
            </a:r>
            <a:r>
              <a:rPr lang="en-GB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abetes compared to women with no type of diabetes in spontaneous labour onset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Bildobjekt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6173" y="1587802"/>
            <a:ext cx="7468949" cy="48504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753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AF83B07080ED4046999E072E00E3CD19" ma:contentTypeVersion="3" ma:contentTypeDescription="Skapa ett nytt dokument." ma:contentTypeScope="" ma:versionID="4a0b2b272e3bdcf2ec20997471c4ca2b">
  <xsd:schema xmlns:xsd="http://www.w3.org/2001/XMLSchema" xmlns:xs="http://www.w3.org/2001/XMLSchema" xmlns:p="http://schemas.microsoft.com/office/2006/metadata/properties" xmlns:ns2="74c8418d-bdb4-40fb-b8b0-519145ff7f89" targetNamespace="http://schemas.microsoft.com/office/2006/metadata/properties" ma:root="true" ma:fieldsID="49f8128f9511c577096a2378380b154d" ns2:_="">
    <xsd:import namespace="74c8418d-bdb4-40fb-b8b0-519145ff7f8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c8418d-bdb4-40fb-b8b0-519145ff7f8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ehållstyp"/>
        <xsd:element ref="dc:title" minOccurs="0" maxOccurs="1" ma:index="4" ma:displayName="Rubrik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35AC497-22B3-434F-B57B-6024FF6B4D85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067E857-5A02-4866-8D3A-91ABF93C927A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74c8418d-bdb4-40fb-b8b0-519145ff7f8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59BB6B55-35A1-4FED-B00C-2A27B680018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4c8418d-bdb4-40fb-b8b0-519145ff7f8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9</TotalTime>
  <Words>29</Words>
  <Application>Microsoft Office PowerPoint</Application>
  <PresentationFormat>Bred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Figure S3a: Kaplan Meier survival analysis on duration of active labour in women with pregestational diabetes compared to women with no type of diabetes in spontaneous labour onset</vt:lpstr>
    </vt:vector>
  </TitlesOfParts>
  <Company>Region Östergöt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X a: Kaplan Meier survival analysis on time in active labour in women with type 1 diabetes compared to women with no (type 1) diabetes in spontaneous labour onset</dc:title>
  <dc:creator>Nevander Sofia</dc:creator>
  <cp:lastModifiedBy>Nevander Sofia</cp:lastModifiedBy>
  <cp:revision>17</cp:revision>
  <dcterms:created xsi:type="dcterms:W3CDTF">2023-05-26T07:08:39Z</dcterms:created>
  <dcterms:modified xsi:type="dcterms:W3CDTF">2025-06-16T08:20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F83B07080ED4046999E072E00E3CD19</vt:lpwstr>
  </property>
</Properties>
</file>